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70" d="100"/>
          <a:sy n="70" d="100"/>
        </p:scale>
        <p:origin x="2760" y="7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4E7284C-DD0C-4A5C-B8DA-4A68FAF39B4D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BD08DCE-977D-42A6-98F5-5034E2B6D31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654264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BD08DCE-977D-42A6-98F5-5034E2B6D313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424539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FBBA5-E51D-405B-83D2-5D4807B741C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0CB24-0E65-4487-9B5B-0824EB4B4F2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076774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FBBA5-E51D-405B-83D2-5D4807B741C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0CB24-0E65-4487-9B5B-0824EB4B4F2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05571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FBBA5-E51D-405B-83D2-5D4807B741C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0CB24-0E65-4487-9B5B-0824EB4B4F2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853499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FBBA5-E51D-405B-83D2-5D4807B741C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0CB24-0E65-4487-9B5B-0824EB4B4F2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228873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FBBA5-E51D-405B-83D2-5D4807B741C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0CB24-0E65-4487-9B5B-0824EB4B4F2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524038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FBBA5-E51D-405B-83D2-5D4807B741C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0CB24-0E65-4487-9B5B-0824EB4B4F2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554675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FBBA5-E51D-405B-83D2-5D4807B741C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0CB24-0E65-4487-9B5B-0824EB4B4F2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532521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FBBA5-E51D-405B-83D2-5D4807B741C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0CB24-0E65-4487-9B5B-0824EB4B4F2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900290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FBBA5-E51D-405B-83D2-5D4807B741C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0CB24-0E65-4487-9B5B-0824EB4B4F2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86217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FBBA5-E51D-405B-83D2-5D4807B741C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0CB24-0E65-4487-9B5B-0824EB4B4F2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710441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9FBBA5-E51D-405B-83D2-5D4807B741C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C0CB24-0E65-4487-9B5B-0824EB4B4F2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710964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9FBBA5-E51D-405B-83D2-5D4807B741C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C0CB24-0E65-4487-9B5B-0824EB4B4F2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215153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t 4">
            <a:extLst>
              <a:ext uri="{FF2B5EF4-FFF2-40B4-BE49-F238E27FC236}">
                <a16:creationId xmlns:a16="http://schemas.microsoft.com/office/drawing/2014/main" id="{2C96D1B0-29C9-615D-4F5A-6072C76F35B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9145642"/>
              </p:ext>
            </p:extLst>
          </p:nvPr>
        </p:nvGraphicFramePr>
        <p:xfrm>
          <a:off x="2644259" y="1087761"/>
          <a:ext cx="1833883" cy="22024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2115091" imgH="2750467" progId="Prism9.Document">
                  <p:embed/>
                </p:oleObj>
              </mc:Choice>
              <mc:Fallback>
                <p:oleObj name="Prism 9" r:id="rId3" imgW="2115091" imgH="2750467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644259" y="1087761"/>
                        <a:ext cx="1833883" cy="22024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t 12">
            <a:extLst>
              <a:ext uri="{FF2B5EF4-FFF2-40B4-BE49-F238E27FC236}">
                <a16:creationId xmlns:a16="http://schemas.microsoft.com/office/drawing/2014/main" id="{AE2BCA30-D52F-6A6F-DBA8-EBC8976F507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83303365"/>
              </p:ext>
            </p:extLst>
          </p:nvPr>
        </p:nvGraphicFramePr>
        <p:xfrm>
          <a:off x="4338115" y="1061383"/>
          <a:ext cx="1856725" cy="222987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5" imgW="2115091" imgH="2750467" progId="Prism9.Document">
                  <p:embed/>
                </p:oleObj>
              </mc:Choice>
              <mc:Fallback>
                <p:oleObj name="Prism 9" r:id="rId5" imgW="2115091" imgH="2750467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338115" y="1061383"/>
                        <a:ext cx="1856725" cy="222987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8" name="Rectangle 47">
            <a:extLst>
              <a:ext uri="{FF2B5EF4-FFF2-40B4-BE49-F238E27FC236}">
                <a16:creationId xmlns:a16="http://schemas.microsoft.com/office/drawing/2014/main" id="{4F413355-D87B-FA03-6918-459DAA6F82AD}"/>
              </a:ext>
            </a:extLst>
          </p:cNvPr>
          <p:cNvSpPr/>
          <p:nvPr/>
        </p:nvSpPr>
        <p:spPr>
          <a:xfrm>
            <a:off x="1099614" y="2036554"/>
            <a:ext cx="1940252" cy="30102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=0.0058</a:t>
            </a: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01E705F6-D597-8293-053D-9856E1C6453D}"/>
              </a:ext>
            </a:extLst>
          </p:cNvPr>
          <p:cNvSpPr/>
          <p:nvPr/>
        </p:nvSpPr>
        <p:spPr>
          <a:xfrm>
            <a:off x="2673832" y="1927421"/>
            <a:ext cx="1940252" cy="40136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=0.0070</a:t>
            </a:r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F2367F5D-973C-D635-CEF6-C49835E73F1A}"/>
              </a:ext>
            </a:extLst>
          </p:cNvPr>
          <p:cNvSpPr/>
          <p:nvPr/>
        </p:nvSpPr>
        <p:spPr>
          <a:xfrm>
            <a:off x="4374328" y="2138437"/>
            <a:ext cx="1940252" cy="40136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=0.0175</a:t>
            </a:r>
          </a:p>
        </p:txBody>
      </p:sp>
      <p:sp>
        <p:nvSpPr>
          <p:cNvPr id="4" name="ZoneTexte 3"/>
          <p:cNvSpPr txBox="1"/>
          <p:nvPr/>
        </p:nvSpPr>
        <p:spPr>
          <a:xfrm>
            <a:off x="266701" y="3798277"/>
            <a:ext cx="6372225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ig, S1. Expression of anti-angiogenic miRNAs in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ProtheraCytes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®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nd secreted exosomes. Total RNA from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ProtheraCytes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Cells) and their exosomes collected from AMI patients were subjected to real time PCR and normalized to small RNA (let-7a) (miR-34a and miR-143: Mann-Whitney test, miR-506: t-test, n=7).</a:t>
            </a:r>
            <a:endParaRPr lang="fr-FR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ZoneTexte 5"/>
          <p:cNvSpPr txBox="1"/>
          <p:nvPr/>
        </p:nvSpPr>
        <p:spPr>
          <a:xfrm>
            <a:off x="423338" y="638431"/>
            <a:ext cx="30056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  <p:graphicFrame>
        <p:nvGraphicFramePr>
          <p:cNvPr id="2" name="Objet 1">
            <a:extLst>
              <a:ext uri="{FF2B5EF4-FFF2-40B4-BE49-F238E27FC236}">
                <a16:creationId xmlns:a16="http://schemas.microsoft.com/office/drawing/2014/main" id="{829C0428-15E9-3BB2-7CF5-F01142A44E8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86063326"/>
              </p:ext>
            </p:extLst>
          </p:nvPr>
        </p:nvGraphicFramePr>
        <p:xfrm>
          <a:off x="1094255" y="1069896"/>
          <a:ext cx="1705341" cy="221873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7" imgW="2115091" imgH="2750467" progId="Prism9.Document">
                  <p:embed/>
                </p:oleObj>
              </mc:Choice>
              <mc:Fallback>
                <p:oleObj name="Prism 9" r:id="rId7" imgW="2115091" imgH="2750467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094255" y="1069896"/>
                        <a:ext cx="1705341" cy="221873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47633981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9</TotalTime>
  <Words>72</Words>
  <Application>Microsoft Office PowerPoint</Application>
  <PresentationFormat>On-screen Show (4:3)</PresentationFormat>
  <Paragraphs>6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hème Office</vt:lpstr>
      <vt:lpstr>Prism 9</vt:lpstr>
      <vt:lpstr>PowerPoint Presentation</vt:lpstr>
    </vt:vector>
  </TitlesOfParts>
  <Company>HA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LAHLIL Rachid</dc:creator>
  <cp:lastModifiedBy>Ibon Garitaonandia</cp:lastModifiedBy>
  <cp:revision>5</cp:revision>
  <dcterms:created xsi:type="dcterms:W3CDTF">2023-10-09T12:46:31Z</dcterms:created>
  <dcterms:modified xsi:type="dcterms:W3CDTF">2023-10-10T13:39:03Z</dcterms:modified>
</cp:coreProperties>
</file>